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8" r:id="rId2"/>
    <p:sldId id="269" r:id="rId3"/>
    <p:sldId id="279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howGuides="1">
      <p:cViewPr varScale="1">
        <p:scale>
          <a:sx n="111" d="100"/>
          <a:sy n="111" d="100"/>
        </p:scale>
        <p:origin x="440" y="19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roupa1\Desktop\%25%20glycopeptides%20RB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roupa1\Desktop\%25%20glycopeptides%20RBD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roupa1\Desktop\%25%20glycopeptides%20RBD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roupa1\Desktop\%25%20glycopeptides%20RBD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sz="1200" b="1"/>
              <a:t>Glycan distribution on VFNATR  of BY2-RBD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title>
    <c:autoTitleDeleted val="0"/>
    <c:plotArea>
      <c:layout>
        <c:manualLayout>
          <c:layoutTarget val="inner"/>
          <c:xMode val="edge"/>
          <c:yMode val="edge"/>
          <c:x val="0.12870603674540684"/>
          <c:y val="0.19486111111111112"/>
          <c:w val="0.87129396325459318"/>
          <c:h val="0.645193205016039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VTT!$O$3</c:f>
              <c:strCache>
                <c:ptCount val="1"/>
                <c:pt idx="0">
                  <c:v>Pourcentage intensité relativ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VTT!$M$4:$M$24</c:f>
              <c:strCache>
                <c:ptCount val="21"/>
                <c:pt idx="0">
                  <c:v>M3</c:v>
                </c:pt>
                <c:pt idx="1">
                  <c:v>M4</c:v>
                </c:pt>
                <c:pt idx="2">
                  <c:v>M5</c:v>
                </c:pt>
                <c:pt idx="3">
                  <c:v>M6</c:v>
                </c:pt>
                <c:pt idx="4">
                  <c:v>M7</c:v>
                </c:pt>
                <c:pt idx="5">
                  <c:v>M8</c:v>
                </c:pt>
                <c:pt idx="6">
                  <c:v>M9</c:v>
                </c:pt>
                <c:pt idx="7">
                  <c:v>Hex10</c:v>
                </c:pt>
                <c:pt idx="8">
                  <c:v>M2X</c:v>
                </c:pt>
                <c:pt idx="9">
                  <c:v>M3X</c:v>
                </c:pt>
                <c:pt idx="10">
                  <c:v>M3Gn</c:v>
                </c:pt>
                <c:pt idx="11">
                  <c:v>M3XF</c:v>
                </c:pt>
                <c:pt idx="12">
                  <c:v>GnX</c:v>
                </c:pt>
                <c:pt idx="13">
                  <c:v>M4Gn</c:v>
                </c:pt>
                <c:pt idx="14">
                  <c:v>Gn2</c:v>
                </c:pt>
                <c:pt idx="15">
                  <c:v>GnXF</c:v>
                </c:pt>
                <c:pt idx="16">
                  <c:v>M4GnX</c:v>
                </c:pt>
                <c:pt idx="17">
                  <c:v>M5Gn</c:v>
                </c:pt>
                <c:pt idx="18">
                  <c:v>Gn2X</c:v>
                </c:pt>
                <c:pt idx="19">
                  <c:v>GnM5X</c:v>
                </c:pt>
                <c:pt idx="20">
                  <c:v>Gn2XF</c:v>
                </c:pt>
              </c:strCache>
            </c:strRef>
          </c:cat>
          <c:val>
            <c:numRef>
              <c:f>VTT!$O$4:$O$24</c:f>
              <c:numCache>
                <c:formatCode>0.00</c:formatCode>
                <c:ptCount val="21"/>
                <c:pt idx="0">
                  <c:v>0.15064935064935067</c:v>
                </c:pt>
                <c:pt idx="1">
                  <c:v>0.40454545454545454</c:v>
                </c:pt>
                <c:pt idx="2">
                  <c:v>1.2857142857142856</c:v>
                </c:pt>
                <c:pt idx="3">
                  <c:v>1.7337662337662336</c:v>
                </c:pt>
                <c:pt idx="4">
                  <c:v>72.077922077922068</c:v>
                </c:pt>
                <c:pt idx="5">
                  <c:v>0.39935064935064934</c:v>
                </c:pt>
                <c:pt idx="6">
                  <c:v>2.5844155844155843</c:v>
                </c:pt>
                <c:pt idx="7">
                  <c:v>0.22142857142857147</c:v>
                </c:pt>
                <c:pt idx="8">
                  <c:v>0.75974025974025972</c:v>
                </c:pt>
                <c:pt idx="9">
                  <c:v>0.56753246753246755</c:v>
                </c:pt>
                <c:pt idx="10">
                  <c:v>0.34935064935064941</c:v>
                </c:pt>
                <c:pt idx="11">
                  <c:v>0.87012987012987009</c:v>
                </c:pt>
                <c:pt idx="12">
                  <c:v>2.3051948051948048</c:v>
                </c:pt>
                <c:pt idx="13">
                  <c:v>0.15</c:v>
                </c:pt>
                <c:pt idx="14">
                  <c:v>8.8311688311688313E-2</c:v>
                </c:pt>
                <c:pt idx="15">
                  <c:v>3.0259740259740262</c:v>
                </c:pt>
                <c:pt idx="16">
                  <c:v>0.35000000000000003</c:v>
                </c:pt>
                <c:pt idx="17">
                  <c:v>0.16233766233766234</c:v>
                </c:pt>
                <c:pt idx="18">
                  <c:v>1.4870129870129871</c:v>
                </c:pt>
                <c:pt idx="19">
                  <c:v>0.28896103896103892</c:v>
                </c:pt>
                <c:pt idx="20">
                  <c:v>10.7142857142857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EC-4D24-957A-216DDD7B9D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52514640"/>
        <c:axId val="1950113264"/>
      </c:barChart>
      <c:catAx>
        <c:axId val="19525146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950113264"/>
        <c:crosses val="autoZero"/>
        <c:auto val="1"/>
        <c:lblAlgn val="ctr"/>
        <c:lblOffset val="100"/>
        <c:noMultiLvlLbl val="0"/>
      </c:catAx>
      <c:valAx>
        <c:axId val="19501132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952514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1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fr-FR" sz="1200" b="1" i="0" baseline="0">
                <a:effectLst/>
              </a:rPr>
              <a:t>Glycan distribution on FPNITNLCPFGE  of BY2-RBD </a:t>
            </a:r>
            <a:endParaRPr lang="fr-FR" sz="1200" b="1">
              <a:effectLst/>
            </a:endParaRPr>
          </a:p>
        </c:rich>
      </c:tx>
      <c:layout>
        <c:manualLayout>
          <c:xMode val="edge"/>
          <c:yMode val="edge"/>
          <c:x val="0.12680555555555556"/>
          <c:y val="2.03252032520325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400" b="1" i="0" u="none" strike="noStrike" kern="1200" spc="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+mn-lt"/>
              <a:ea typeface="+mn-ea"/>
              <a:cs typeface="+mn-cs"/>
            </a:defRPr>
          </a:pPr>
          <a:endParaRPr lang="it-I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VTT!$N$29:$N$41</c:f>
              <c:strCache>
                <c:ptCount val="13"/>
                <c:pt idx="0">
                  <c:v>M3</c:v>
                </c:pt>
                <c:pt idx="1">
                  <c:v>M4</c:v>
                </c:pt>
                <c:pt idx="2">
                  <c:v>M5</c:v>
                </c:pt>
                <c:pt idx="3">
                  <c:v>M6</c:v>
                </c:pt>
                <c:pt idx="4">
                  <c:v>M7</c:v>
                </c:pt>
                <c:pt idx="5">
                  <c:v>M2X</c:v>
                </c:pt>
                <c:pt idx="6">
                  <c:v>M3X</c:v>
                </c:pt>
                <c:pt idx="7">
                  <c:v>GnM3</c:v>
                </c:pt>
                <c:pt idx="8">
                  <c:v>M3XF</c:v>
                </c:pt>
                <c:pt idx="9">
                  <c:v>GnX</c:v>
                </c:pt>
                <c:pt idx="10">
                  <c:v>GnXF</c:v>
                </c:pt>
                <c:pt idx="11">
                  <c:v>GnM5</c:v>
                </c:pt>
                <c:pt idx="12">
                  <c:v>Gn2X</c:v>
                </c:pt>
              </c:strCache>
            </c:strRef>
          </c:cat>
          <c:val>
            <c:numRef>
              <c:f>VTT!$P$29:$P$41</c:f>
              <c:numCache>
                <c:formatCode>0.00</c:formatCode>
                <c:ptCount val="13"/>
                <c:pt idx="0">
                  <c:v>4.6796116504854375</c:v>
                </c:pt>
                <c:pt idx="1">
                  <c:v>3.3689320388349513</c:v>
                </c:pt>
                <c:pt idx="2">
                  <c:v>13.398058252427186</c:v>
                </c:pt>
                <c:pt idx="3">
                  <c:v>2.4951456310679609</c:v>
                </c:pt>
                <c:pt idx="4">
                  <c:v>53.592233009708742</c:v>
                </c:pt>
                <c:pt idx="5">
                  <c:v>1.145631067961165</c:v>
                </c:pt>
                <c:pt idx="6">
                  <c:v>1.6699029126213591</c:v>
                </c:pt>
                <c:pt idx="7">
                  <c:v>1.0970873786407767</c:v>
                </c:pt>
                <c:pt idx="8">
                  <c:v>3.1844660194174756</c:v>
                </c:pt>
                <c:pt idx="9">
                  <c:v>4.2038834951456314</c:v>
                </c:pt>
                <c:pt idx="10">
                  <c:v>7.2135922330097078</c:v>
                </c:pt>
                <c:pt idx="11">
                  <c:v>1.5436893203883495</c:v>
                </c:pt>
                <c:pt idx="12">
                  <c:v>2.6796116504854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15C-48EF-A582-6B148B5D3A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50072720"/>
        <c:axId val="1836364480"/>
      </c:barChart>
      <c:catAx>
        <c:axId val="1950072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836364480"/>
        <c:crosses val="autoZero"/>
        <c:auto val="1"/>
        <c:lblAlgn val="ctr"/>
        <c:lblOffset val="100"/>
        <c:noMultiLvlLbl val="0"/>
      </c:catAx>
      <c:valAx>
        <c:axId val="18363644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950072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sz="1200" b="1" i="0" baseline="0">
                <a:effectLst/>
              </a:rPr>
              <a:t>Glycan distribution on VFNATR  of NB-RBD </a:t>
            </a:r>
            <a:endParaRPr lang="fr-FR" sz="120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DIAMANTE!$J$6:$J$16</c:f>
              <c:strCache>
                <c:ptCount val="11"/>
                <c:pt idx="0">
                  <c:v>M5</c:v>
                </c:pt>
                <c:pt idx="1">
                  <c:v>M6</c:v>
                </c:pt>
                <c:pt idx="2">
                  <c:v>M7</c:v>
                </c:pt>
                <c:pt idx="3">
                  <c:v>M8</c:v>
                </c:pt>
                <c:pt idx="4">
                  <c:v>M9</c:v>
                </c:pt>
                <c:pt idx="5">
                  <c:v>M3X</c:v>
                </c:pt>
                <c:pt idx="6">
                  <c:v>M3XF</c:v>
                </c:pt>
                <c:pt idx="7">
                  <c:v>GnXF</c:v>
                </c:pt>
                <c:pt idx="8">
                  <c:v>Gn2X</c:v>
                </c:pt>
                <c:pt idx="9">
                  <c:v>Gn2XF</c:v>
                </c:pt>
                <c:pt idx="10">
                  <c:v>LeaXF</c:v>
                </c:pt>
              </c:strCache>
            </c:strRef>
          </c:cat>
          <c:val>
            <c:numRef>
              <c:f>DIAMANTE!$L$6:$L$16</c:f>
              <c:numCache>
                <c:formatCode>0.00</c:formatCode>
                <c:ptCount val="11"/>
                <c:pt idx="0">
                  <c:v>4.4368600682593859</c:v>
                </c:pt>
                <c:pt idx="1">
                  <c:v>5.4607508532423212</c:v>
                </c:pt>
                <c:pt idx="2">
                  <c:v>6.9965870307167233</c:v>
                </c:pt>
                <c:pt idx="3">
                  <c:v>15.358361774744028</c:v>
                </c:pt>
                <c:pt idx="4">
                  <c:v>21.16040955631399</c:v>
                </c:pt>
                <c:pt idx="5">
                  <c:v>2.7303754266211606</c:v>
                </c:pt>
                <c:pt idx="6">
                  <c:v>11.490329920364051</c:v>
                </c:pt>
                <c:pt idx="7">
                  <c:v>2.5028441410693971</c:v>
                </c:pt>
                <c:pt idx="8">
                  <c:v>2.9579067121729237</c:v>
                </c:pt>
                <c:pt idx="9">
                  <c:v>17.690557451649603</c:v>
                </c:pt>
                <c:pt idx="10">
                  <c:v>9.21501706484641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7C1-4221-A8CF-44A1E27ACF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66292064"/>
        <c:axId val="1964897872"/>
      </c:barChart>
      <c:catAx>
        <c:axId val="1966292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964897872"/>
        <c:crosses val="autoZero"/>
        <c:auto val="1"/>
        <c:lblAlgn val="ctr"/>
        <c:lblOffset val="100"/>
        <c:noMultiLvlLbl val="0"/>
      </c:catAx>
      <c:valAx>
        <c:axId val="19648978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9662920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sz="1200" b="1" i="0" baseline="0">
                <a:effectLst/>
              </a:rPr>
              <a:t>Glycan distribution on VQPTESIVRFPNITNLCPFGE  of NB-RBD </a:t>
            </a:r>
            <a:endParaRPr lang="fr-FR" sz="1200" b="1">
              <a:effectLst/>
            </a:endParaRPr>
          </a:p>
        </c:rich>
      </c:tx>
      <c:layout>
        <c:manualLayout>
          <c:xMode val="edge"/>
          <c:yMode val="edge"/>
          <c:x val="0.13434711286089238"/>
          <c:y val="4.166666666666666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DIAMANTE!$I$21</c:f>
              <c:strCache>
                <c:ptCount val="1"/>
                <c:pt idx="0">
                  <c:v>Pourcentage intensité relativ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DIAMANTE!$G$22:$G$29</c:f>
              <c:strCache>
                <c:ptCount val="8"/>
                <c:pt idx="0">
                  <c:v>M7</c:v>
                </c:pt>
                <c:pt idx="1">
                  <c:v>M8</c:v>
                </c:pt>
                <c:pt idx="2">
                  <c:v>M3XF</c:v>
                </c:pt>
                <c:pt idx="3">
                  <c:v>GnXF</c:v>
                </c:pt>
                <c:pt idx="4">
                  <c:v>Gn2XF</c:v>
                </c:pt>
                <c:pt idx="5">
                  <c:v>LeaXF</c:v>
                </c:pt>
                <c:pt idx="6">
                  <c:v>LeaGnXF</c:v>
                </c:pt>
                <c:pt idx="7">
                  <c:v>Lea2XF</c:v>
                </c:pt>
              </c:strCache>
            </c:strRef>
          </c:cat>
          <c:val>
            <c:numRef>
              <c:f>DIAMANTE!$I$22:$I$29</c:f>
              <c:numCache>
                <c:formatCode>0.00</c:formatCode>
                <c:ptCount val="8"/>
                <c:pt idx="0">
                  <c:v>7.4468085106382986</c:v>
                </c:pt>
                <c:pt idx="1">
                  <c:v>10.638297872340427</c:v>
                </c:pt>
                <c:pt idx="2">
                  <c:v>10.638297872340427</c:v>
                </c:pt>
                <c:pt idx="3">
                  <c:v>13.829787234042554</c:v>
                </c:pt>
                <c:pt idx="4">
                  <c:v>26.595744680851062</c:v>
                </c:pt>
                <c:pt idx="5">
                  <c:v>15.957446808510639</c:v>
                </c:pt>
                <c:pt idx="6">
                  <c:v>10.638297872340427</c:v>
                </c:pt>
                <c:pt idx="7">
                  <c:v>4.2553191489361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C64-471D-9D89-5F28E54F2C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69719984"/>
        <c:axId val="1267117840"/>
      </c:barChart>
      <c:catAx>
        <c:axId val="1269719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267117840"/>
        <c:crosses val="autoZero"/>
        <c:auto val="1"/>
        <c:lblAlgn val="ctr"/>
        <c:lblOffset val="100"/>
        <c:noMultiLvlLbl val="0"/>
      </c:catAx>
      <c:valAx>
        <c:axId val="12671178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2697199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FF53DDB-D6D1-5DBF-03AD-8F4E2F1E76E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F0B77894-8D80-CF83-45A2-88A25F06946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0A7FDA2-D4A3-A62D-1FFF-2586507177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5EEA8-CC76-E148-8CE6-FB23C6274339}" type="datetimeFigureOut">
              <a:rPr lang="it-IT" smtClean="0"/>
              <a:t>13/10/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3F6E1D7-D3CB-9BF9-5F82-888B78FD14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E5CEBA7-6407-C32E-CB8C-9B8F0740D7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6E440-1F8E-AA4E-9C72-D6A7E2EEF9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57032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0DF68B1-5E49-9CCC-C380-1157424964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A233E92-F72B-F78A-A77B-70F6433C79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732D58D-9B1F-678F-8172-B74FC1563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5EEA8-CC76-E148-8CE6-FB23C6274339}" type="datetimeFigureOut">
              <a:rPr lang="it-IT" smtClean="0"/>
              <a:t>13/10/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662C27D-1510-9567-14DD-2046C2B345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28D76C6-25EA-2110-F557-1E9E1AF703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6E440-1F8E-AA4E-9C72-D6A7E2EEF9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79056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5CF79BAD-C802-4F6E-F4B6-3FF26A5EF15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68EE2CB-A569-99E1-A3DD-316177633B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5E480A1-12A4-C639-3981-3291C04845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5EEA8-CC76-E148-8CE6-FB23C6274339}" type="datetimeFigureOut">
              <a:rPr lang="it-IT" smtClean="0"/>
              <a:t>13/10/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40466FD-40F0-6895-458F-426982DC75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7C923E8-24E6-6EA9-4769-7D25313CE8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6E440-1F8E-AA4E-9C72-D6A7E2EEF9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13683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2FDE2C5-3F73-B920-F29A-577BB19812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F7635E5-85CB-EDAA-3D86-02364F7484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03A3C88-4E7F-B734-7164-7E9C475672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5EEA8-CC76-E148-8CE6-FB23C6274339}" type="datetimeFigureOut">
              <a:rPr lang="it-IT" smtClean="0"/>
              <a:t>13/10/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49C105C-BF1C-91E3-E291-555627291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44878F6-68D8-17A3-47D8-CB4540055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6E440-1F8E-AA4E-9C72-D6A7E2EEF9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51957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7F0795B-D530-D078-61A7-9F14101FBB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B85FECB-B037-4531-2F04-2EF802F070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F3440FC-8982-CC4B-EF98-13A23B380A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5EEA8-CC76-E148-8CE6-FB23C6274339}" type="datetimeFigureOut">
              <a:rPr lang="it-IT" smtClean="0"/>
              <a:t>13/10/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B92ED87-1E11-34C3-FD5B-B8FF721F4B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D1E2373-4897-F6F8-9FEB-228DE9536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6E440-1F8E-AA4E-9C72-D6A7E2EEF9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0759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E5D58F4-7BD1-6EFC-FF8B-B679A83EAC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14BDC1D-92AB-5B08-E014-5676E6DA86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B3D012C-3A9A-13D2-FBC7-3C4CB64B37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396A479-FD70-B7E0-825A-1493F4B11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5EEA8-CC76-E148-8CE6-FB23C6274339}" type="datetimeFigureOut">
              <a:rPr lang="it-IT" smtClean="0"/>
              <a:t>13/10/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D723A87-164A-1597-3FF1-58E003056C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1D76A94-75A1-2879-CABF-CDDDCB5FC8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6E440-1F8E-AA4E-9C72-D6A7E2EEF9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03887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D5CFB31-8929-E275-6B93-13E473175E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1DBECE5-CDD5-7D5F-2016-0B5DC0F50A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240B1251-0203-21C1-ACDA-1FB86778BC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CDC149F-E719-D454-4D52-CFBE26F51DC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BA777FD-DAF1-B959-3683-C4A14EF64B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CAFC0BAD-919F-44E5-4ECE-B4008095B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5EEA8-CC76-E148-8CE6-FB23C6274339}" type="datetimeFigureOut">
              <a:rPr lang="it-IT" smtClean="0"/>
              <a:t>13/10/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8B597B4-DB0B-7ABA-0E35-E532644C26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D32C3EF-C1B0-E8B9-E82D-0630EAB68A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6E440-1F8E-AA4E-9C72-D6A7E2EEF9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00600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1AFADED-7EFB-3175-814A-E918DC048B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B6550CED-5822-D240-BE3C-2CDA74571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5EEA8-CC76-E148-8CE6-FB23C6274339}" type="datetimeFigureOut">
              <a:rPr lang="it-IT" smtClean="0"/>
              <a:t>13/10/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5FE9AB93-B9CD-BF30-8568-067E720B69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05292D20-FE25-589C-0D20-C1E0C700A3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6E440-1F8E-AA4E-9C72-D6A7E2EEF9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94206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DBAE3030-E3F9-27EC-0846-B41322F610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5EEA8-CC76-E148-8CE6-FB23C6274339}" type="datetimeFigureOut">
              <a:rPr lang="it-IT" smtClean="0"/>
              <a:t>13/10/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347542AA-9A04-2075-BC57-6F2FACB175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A61560FC-9709-76B5-1092-C210722A3A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6E440-1F8E-AA4E-9C72-D6A7E2EEF9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984738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6A95DF3-2129-8E6C-6EFD-E857BC7073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BE154CB-23FF-C230-A7F7-D03EC824C9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3BC8D3C-F55A-14CE-16AF-369BBCD5C3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8AF45FC-3E35-C218-D70E-726AE61B81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5EEA8-CC76-E148-8CE6-FB23C6274339}" type="datetimeFigureOut">
              <a:rPr lang="it-IT" smtClean="0"/>
              <a:t>13/10/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2CC9467-371C-9818-6A2D-AF4635290D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7031195-88A5-5482-922B-E9F2191A44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6E440-1F8E-AA4E-9C72-D6A7E2EEF9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371618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5EF0DEC-3A54-BA0C-00D4-1B7962D52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46A0A9B8-0E8F-40A6-B630-003CA44B6E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F6E40E0-E956-C91C-8D3D-F0E0E94170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9A60FE0-D4F7-8356-46A5-8822E0D09D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5EEA8-CC76-E148-8CE6-FB23C6274339}" type="datetimeFigureOut">
              <a:rPr lang="it-IT" smtClean="0"/>
              <a:t>13/10/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DF69216-5A6D-2258-0C19-43C3BBA3ED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80E5B1E-43EC-6969-869B-FF93C6EB92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6E440-1F8E-AA4E-9C72-D6A7E2EEF9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296292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69B9FEE3-011F-5561-4CC3-CBBEC5FE0A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7346FC2-49DD-A573-1BFE-7175E9D5EC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81E2983-E28F-785F-2439-FC218555B7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C5EEA8-CC76-E148-8CE6-FB23C6274339}" type="datetimeFigureOut">
              <a:rPr lang="it-IT" smtClean="0"/>
              <a:t>13/10/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295DB83-4BBB-0379-59D0-FAE3EC69B6F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F666C46-DB08-6000-2016-B90728F7C5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56E440-1F8E-AA4E-9C72-D6A7E2EEF98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70113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06CBEBCD-F27F-4C4D-A5AC-A600CBDBD6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7526" y="154253"/>
            <a:ext cx="7417479" cy="2248606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4B1AE03B-4E2C-4273-8A2A-368D3934F26B}"/>
              </a:ext>
            </a:extLst>
          </p:cNvPr>
          <p:cNvSpPr/>
          <p:nvPr/>
        </p:nvSpPr>
        <p:spPr>
          <a:xfrm>
            <a:off x="5979042" y="154253"/>
            <a:ext cx="246490" cy="2075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3B88F61-2B4A-4601-A168-AB1467809AFE}"/>
              </a:ext>
            </a:extLst>
          </p:cNvPr>
          <p:cNvSpPr/>
          <p:nvPr/>
        </p:nvSpPr>
        <p:spPr>
          <a:xfrm>
            <a:off x="7021988" y="154253"/>
            <a:ext cx="246490" cy="2075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56B0ECFF-3DA4-4F17-8D31-00CA8322A7EE}"/>
              </a:ext>
            </a:extLst>
          </p:cNvPr>
          <p:cNvSpPr txBox="1"/>
          <p:nvPr/>
        </p:nvSpPr>
        <p:spPr>
          <a:xfrm>
            <a:off x="1766386" y="68450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(A)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DE14587C-4473-4F98-9BF4-B5133BF11086}"/>
              </a:ext>
            </a:extLst>
          </p:cNvPr>
          <p:cNvSpPr txBox="1"/>
          <p:nvPr/>
        </p:nvSpPr>
        <p:spPr>
          <a:xfrm>
            <a:off x="1766386" y="2456019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(B)</a:t>
            </a:r>
          </a:p>
        </p:txBody>
      </p:sp>
      <p:pic>
        <p:nvPicPr>
          <p:cNvPr id="15" name="Image 14">
            <a:extLst>
              <a:ext uri="{FF2B5EF4-FFF2-40B4-BE49-F238E27FC236}">
                <a16:creationId xmlns:a16="http://schemas.microsoft.com/office/drawing/2014/main" id="{CA1F93ED-6C87-4946-A6D6-DBFE67B81B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9422" y="2328671"/>
            <a:ext cx="6128277" cy="3070230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AB1F2AFA-704A-4822-A304-FE5B47ACCF8A}"/>
              </a:ext>
            </a:extLst>
          </p:cNvPr>
          <p:cNvSpPr/>
          <p:nvPr/>
        </p:nvSpPr>
        <p:spPr>
          <a:xfrm>
            <a:off x="6571083" y="2432422"/>
            <a:ext cx="246490" cy="2075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D4C28886-CDFE-40CA-B789-7F65B72EF7DB}"/>
              </a:ext>
            </a:extLst>
          </p:cNvPr>
          <p:cNvSpPr/>
          <p:nvPr/>
        </p:nvSpPr>
        <p:spPr>
          <a:xfrm>
            <a:off x="7450342" y="2432422"/>
            <a:ext cx="246490" cy="2075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D85FC5F3-F342-352E-F87D-9B09C2A6AB73}"/>
              </a:ext>
            </a:extLst>
          </p:cNvPr>
          <p:cNvSpPr txBox="1"/>
          <p:nvPr/>
        </p:nvSpPr>
        <p:spPr>
          <a:xfrm>
            <a:off x="717715" y="6059875"/>
            <a:ext cx="60998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 err="1"/>
              <a:t>Supplementary</a:t>
            </a:r>
            <a:r>
              <a:rPr lang="it-IT" dirty="0"/>
              <a:t> Figure 1</a:t>
            </a:r>
          </a:p>
        </p:txBody>
      </p:sp>
    </p:spTree>
    <p:extLst>
      <p:ext uri="{BB962C8B-B14F-4D97-AF65-F5344CB8AC3E}">
        <p14:creationId xmlns:p14="http://schemas.microsoft.com/office/powerpoint/2010/main" val="15072664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1">
            <a:extLst>
              <a:ext uri="{FF2B5EF4-FFF2-40B4-BE49-F238E27FC236}">
                <a16:creationId xmlns:a16="http://schemas.microsoft.com/office/drawing/2014/main" id="{DE650F2E-C226-E6D0-35E0-09B76D6AD01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5640" y="1868487"/>
            <a:ext cx="5760720" cy="3121025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4F4E84B3-4603-A622-AEE3-81313D792B08}"/>
              </a:ext>
            </a:extLst>
          </p:cNvPr>
          <p:cNvSpPr txBox="1"/>
          <p:nvPr/>
        </p:nvSpPr>
        <p:spPr>
          <a:xfrm>
            <a:off x="578734" y="6099858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Supplementary</a:t>
            </a:r>
            <a:r>
              <a:rPr lang="it-IT" dirty="0"/>
              <a:t> </a:t>
            </a:r>
            <a:r>
              <a:rPr lang="it-IT"/>
              <a:t>Figure 2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5932172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>
            <a:extLst>
              <a:ext uri="{FF2B5EF4-FFF2-40B4-BE49-F238E27FC236}">
                <a16:creationId xmlns:a16="http://schemas.microsoft.com/office/drawing/2014/main" id="{813072CA-3E40-4E06-BF51-AFD0D509E152}"/>
              </a:ext>
            </a:extLst>
          </p:cNvPr>
          <p:cNvGraphicFramePr>
            <a:graphicFrameLocks/>
          </p:cNvGraphicFramePr>
          <p:nvPr/>
        </p:nvGraphicFramePr>
        <p:xfrm>
          <a:off x="978665" y="36080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phique 4">
            <a:extLst>
              <a:ext uri="{FF2B5EF4-FFF2-40B4-BE49-F238E27FC236}">
                <a16:creationId xmlns:a16="http://schemas.microsoft.com/office/drawing/2014/main" id="{C4855C5C-44FE-4D0C-8967-6AACD27B878D}"/>
              </a:ext>
            </a:extLst>
          </p:cNvPr>
          <p:cNvGraphicFramePr>
            <a:graphicFrameLocks/>
          </p:cNvGraphicFramePr>
          <p:nvPr/>
        </p:nvGraphicFramePr>
        <p:xfrm>
          <a:off x="5848120" y="360802"/>
          <a:ext cx="4572000" cy="26408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Graphique 5">
            <a:extLst>
              <a:ext uri="{FF2B5EF4-FFF2-40B4-BE49-F238E27FC236}">
                <a16:creationId xmlns:a16="http://schemas.microsoft.com/office/drawing/2014/main" id="{001BE380-CDF4-4495-AF23-FB30AAA52669}"/>
              </a:ext>
            </a:extLst>
          </p:cNvPr>
          <p:cNvGraphicFramePr>
            <a:graphicFrameLocks/>
          </p:cNvGraphicFramePr>
          <p:nvPr/>
        </p:nvGraphicFramePr>
        <p:xfrm>
          <a:off x="1276120" y="3075712"/>
          <a:ext cx="4572000" cy="27336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Graphique 6">
            <a:extLst>
              <a:ext uri="{FF2B5EF4-FFF2-40B4-BE49-F238E27FC236}">
                <a16:creationId xmlns:a16="http://schemas.microsoft.com/office/drawing/2014/main" id="{6CCB05EB-4D78-467A-B692-DF8DECFF604F}"/>
              </a:ext>
            </a:extLst>
          </p:cNvPr>
          <p:cNvGraphicFramePr>
            <a:graphicFrameLocks/>
          </p:cNvGraphicFramePr>
          <p:nvPr/>
        </p:nvGraphicFramePr>
        <p:xfrm>
          <a:off x="6096000" y="307571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" name="CasellaDiTesto 2">
            <a:extLst>
              <a:ext uri="{FF2B5EF4-FFF2-40B4-BE49-F238E27FC236}">
                <a16:creationId xmlns:a16="http://schemas.microsoft.com/office/drawing/2014/main" id="{0CF49A7C-5B80-C5C4-EC00-F068A971EC57}"/>
              </a:ext>
            </a:extLst>
          </p:cNvPr>
          <p:cNvSpPr txBox="1"/>
          <p:nvPr/>
        </p:nvSpPr>
        <p:spPr>
          <a:xfrm>
            <a:off x="512191" y="6127866"/>
            <a:ext cx="60998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 err="1"/>
              <a:t>Supplementary</a:t>
            </a:r>
            <a:r>
              <a:rPr lang="it-IT" dirty="0"/>
              <a:t> Figure 3</a:t>
            </a:r>
          </a:p>
        </p:txBody>
      </p:sp>
    </p:spTree>
    <p:extLst>
      <p:ext uri="{BB962C8B-B14F-4D97-AF65-F5344CB8AC3E}">
        <p14:creationId xmlns:p14="http://schemas.microsoft.com/office/powerpoint/2010/main" val="375532555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39</Words>
  <Application>Microsoft Macintosh PowerPoint</Application>
  <PresentationFormat>Widescreen</PresentationFormat>
  <Paragraphs>9</Paragraphs>
  <Slides>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inda Avesani</dc:creator>
  <cp:lastModifiedBy>Linda Avesani</cp:lastModifiedBy>
  <cp:revision>3</cp:revision>
  <dcterms:created xsi:type="dcterms:W3CDTF">2023-09-21T15:49:17Z</dcterms:created>
  <dcterms:modified xsi:type="dcterms:W3CDTF">2023-10-13T15:05:09Z</dcterms:modified>
</cp:coreProperties>
</file>